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7.wmf"/><Relationship Id="rId26" Type="http://schemas.openxmlformats.org/officeDocument/2006/relationships/image" Target="../media/image11.wmf"/><Relationship Id="rId3" Type="http://schemas.openxmlformats.org/officeDocument/2006/relationships/image" Target="../media/image14.emf"/><Relationship Id="rId21" Type="http://schemas.openxmlformats.org/officeDocument/2006/relationships/oleObject" Target="../embeddings/oleObject9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wmf"/><Relationship Id="rId17" Type="http://schemas.openxmlformats.org/officeDocument/2006/relationships/oleObject" Target="../embeddings/oleObject7.bin"/><Relationship Id="rId25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.wmf"/><Relationship Id="rId20" Type="http://schemas.openxmlformats.org/officeDocument/2006/relationships/image" Target="../media/image8.wmf"/><Relationship Id="rId29" Type="http://schemas.openxmlformats.org/officeDocument/2006/relationships/oleObject" Target="../embeddings/oleObject13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10.wmf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10.bin"/><Relationship Id="rId28" Type="http://schemas.openxmlformats.org/officeDocument/2006/relationships/image" Target="../media/image12.wmf"/><Relationship Id="rId10" Type="http://schemas.openxmlformats.org/officeDocument/2006/relationships/image" Target="../media/image3.wmf"/><Relationship Id="rId19" Type="http://schemas.openxmlformats.org/officeDocument/2006/relationships/oleObject" Target="../embeddings/oleObject8.bin"/><Relationship Id="rId31" Type="http://schemas.openxmlformats.org/officeDocument/2006/relationships/image" Target="../media/image16.w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wmf"/><Relationship Id="rId22" Type="http://schemas.openxmlformats.org/officeDocument/2006/relationships/image" Target="../media/image9.wmf"/><Relationship Id="rId27" Type="http://schemas.openxmlformats.org/officeDocument/2006/relationships/oleObject" Target="../embeddings/oleObject12.bin"/><Relationship Id="rId30" Type="http://schemas.openxmlformats.org/officeDocument/2006/relationships/image" Target="../media/image1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7E3FCBA-75BE-C240-86E4-C52C1FD573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1800" y="703762"/>
            <a:ext cx="2152276" cy="14436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B706E99-498C-4646-A539-D1391E503761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051800" y="2104411"/>
            <a:ext cx="2160000" cy="1443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62005" y="1446085"/>
            <a:ext cx="237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29895" y="1446085"/>
            <a:ext cx="237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204800" y="1446085"/>
            <a:ext cx="423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42921" y="1446085"/>
            <a:ext cx="478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943676" y="1446085"/>
            <a:ext cx="377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49804" y="1446085"/>
            <a:ext cx="5235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81789" y="1446085"/>
            <a:ext cx="418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00793" y="1446085"/>
            <a:ext cx="872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  <p:graphicFrame>
        <p:nvGraphicFramePr>
          <p:cNvPr id="12" name="Objec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5986829"/>
              </p:ext>
            </p:extLst>
          </p:nvPr>
        </p:nvGraphicFramePr>
        <p:xfrm>
          <a:off x="1555404" y="2050699"/>
          <a:ext cx="108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78" name="Image" r:id="rId5" imgW="1488960" imgH="488520" progId="Photoshop.Image.11">
                  <p:embed/>
                </p:oleObj>
              </mc:Choice>
              <mc:Fallback>
                <p:oleObj name="Image" r:id="rId5" imgW="1488960" imgH="4885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55404" y="2050699"/>
                        <a:ext cx="1080000" cy="3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021663"/>
              </p:ext>
            </p:extLst>
          </p:nvPr>
        </p:nvGraphicFramePr>
        <p:xfrm>
          <a:off x="2626822" y="2050699"/>
          <a:ext cx="108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79" name="Image" r:id="rId7" imgW="1488960" imgH="488520" progId="Photoshop.Image.11">
                  <p:embed/>
                </p:oleObj>
              </mc:Choice>
              <mc:Fallback>
                <p:oleObj name="Image" r:id="rId7" imgW="1488960" imgH="4885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26822" y="2050699"/>
                        <a:ext cx="1080000" cy="3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1540283" y="1680342"/>
            <a:ext cx="2166539" cy="7385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Objec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9486077"/>
              </p:ext>
            </p:extLst>
          </p:nvPr>
        </p:nvGraphicFramePr>
        <p:xfrm>
          <a:off x="1555404" y="1686372"/>
          <a:ext cx="108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0" name="Image" r:id="rId9" imgW="1258920" imgH="420480" progId="Photoshop.Image.11">
                  <p:embed/>
                </p:oleObj>
              </mc:Choice>
              <mc:Fallback>
                <p:oleObj name="Image" r:id="rId9" imgW="1258920" imgH="42048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55404" y="1686372"/>
                        <a:ext cx="1080000" cy="3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8401646"/>
              </p:ext>
            </p:extLst>
          </p:nvPr>
        </p:nvGraphicFramePr>
        <p:xfrm>
          <a:off x="2626822" y="1686372"/>
          <a:ext cx="108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1" name="Image" r:id="rId11" imgW="1258920" imgH="420480" progId="Photoshop.Image.11">
                  <p:embed/>
                </p:oleObj>
              </mc:Choice>
              <mc:Fallback>
                <p:oleObj name="Image" r:id="rId11" imgW="1258920" imgH="42048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626822" y="1686372"/>
                        <a:ext cx="1080000" cy="3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ctangle 16"/>
          <p:cNvSpPr/>
          <p:nvPr/>
        </p:nvSpPr>
        <p:spPr>
          <a:xfrm>
            <a:off x="5127938" y="2615178"/>
            <a:ext cx="8819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***P&lt;0.0001</a:t>
            </a:r>
          </a:p>
        </p:txBody>
      </p:sp>
      <p:sp>
        <p:nvSpPr>
          <p:cNvPr id="18" name="Rectangle 17"/>
          <p:cNvSpPr/>
          <p:nvPr/>
        </p:nvSpPr>
        <p:spPr>
          <a:xfrm>
            <a:off x="5103406" y="1157865"/>
            <a:ext cx="78098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**P=</a:t>
            </a:r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0.006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10290" y="1755989"/>
            <a:ext cx="872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WT MEF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71232" y="2185730"/>
            <a:ext cx="1011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gcn2-/-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EFs</a:t>
            </a:r>
            <a:endParaRPr lang="en-GB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61270" y="6288210"/>
            <a:ext cx="9938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 p-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(S51)</a:t>
            </a:r>
          </a:p>
        </p:txBody>
      </p:sp>
      <p:sp>
        <p:nvSpPr>
          <p:cNvPr id="24" name="Rectangle 23"/>
          <p:cNvSpPr/>
          <p:nvPr/>
        </p:nvSpPr>
        <p:spPr>
          <a:xfrm>
            <a:off x="2696302" y="6585307"/>
            <a:ext cx="45878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488792" y="6778542"/>
            <a:ext cx="66629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β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Tubuli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676036" y="4992503"/>
            <a:ext cx="47904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erk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512305" y="4733222"/>
            <a:ext cx="64277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-Perk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651677" y="5522830"/>
            <a:ext cx="50340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Foxo3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465278" y="4293891"/>
            <a:ext cx="7632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Gcn2: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294181" y="3867659"/>
            <a:ext cx="502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MEF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79412" y="4497340"/>
            <a:ext cx="57566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Gcn2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209201" y="4307220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424850" y="4307220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646048" y="4307220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827972" y="4307220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209201" y="4083103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646048" y="4083103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424850" y="4083103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827972" y="4083103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graphicFrame>
        <p:nvGraphicFramePr>
          <p:cNvPr id="40" name="Objec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2277801"/>
              </p:ext>
            </p:extLst>
          </p:nvPr>
        </p:nvGraphicFramePr>
        <p:xfrm>
          <a:off x="3126810" y="4544313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2" name="Image" r:id="rId13" imgW="755640" imgH="164520" progId="Photoshop.Image.11">
                  <p:embed/>
                </p:oleObj>
              </mc:Choice>
              <mc:Fallback>
                <p:oleObj name="Image" r:id="rId13" imgW="755640" imgH="1645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126810" y="4544313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5605916"/>
              </p:ext>
            </p:extLst>
          </p:nvPr>
        </p:nvGraphicFramePr>
        <p:xfrm>
          <a:off x="3126810" y="4783126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3" name="Image" r:id="rId15" imgW="786240" imgH="152280" progId="Photoshop.Image.11">
                  <p:embed/>
                </p:oleObj>
              </mc:Choice>
              <mc:Fallback>
                <p:oleObj name="Image" r:id="rId15" imgW="786240" imgH="15228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126810" y="4783126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3065542"/>
              </p:ext>
            </p:extLst>
          </p:nvPr>
        </p:nvGraphicFramePr>
        <p:xfrm>
          <a:off x="3126810" y="5035684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4" name="Image" r:id="rId17" imgW="786240" imgH="249840" progId="Photoshop.Image.11">
                  <p:embed/>
                </p:oleObj>
              </mc:Choice>
              <mc:Fallback>
                <p:oleObj name="Image" r:id="rId17" imgW="786240" imgH="24984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126810" y="5035684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7214701"/>
              </p:ext>
            </p:extLst>
          </p:nvPr>
        </p:nvGraphicFramePr>
        <p:xfrm>
          <a:off x="3126810" y="6326179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5" name="Image" r:id="rId19" imgW="798480" imgH="191880" progId="Photoshop.Image.11">
                  <p:embed/>
                </p:oleObj>
              </mc:Choice>
              <mc:Fallback>
                <p:oleObj name="Image" r:id="rId19" imgW="798480" imgH="19188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126810" y="6326179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109333"/>
              </p:ext>
            </p:extLst>
          </p:nvPr>
        </p:nvGraphicFramePr>
        <p:xfrm>
          <a:off x="3126810" y="6578291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6" name="Image" r:id="rId21" imgW="780120" imgH="194760" progId="Photoshop.Image.11">
                  <p:embed/>
                </p:oleObj>
              </mc:Choice>
              <mc:Fallback>
                <p:oleObj name="Image" r:id="rId21" imgW="780120" imgH="19476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126810" y="6578291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44"/>
          <p:cNvSpPr txBox="1"/>
          <p:nvPr/>
        </p:nvSpPr>
        <p:spPr>
          <a:xfrm>
            <a:off x="2227817" y="5239398"/>
            <a:ext cx="92726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-Foxo3(T32)</a:t>
            </a:r>
          </a:p>
        </p:txBody>
      </p:sp>
      <p:graphicFrame>
        <p:nvGraphicFramePr>
          <p:cNvPr id="46" name="Objec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3387674"/>
              </p:ext>
            </p:extLst>
          </p:nvPr>
        </p:nvGraphicFramePr>
        <p:xfrm>
          <a:off x="3126810" y="5294151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7" name="Image" r:id="rId23" imgW="847080" imgH="200880" progId="Photoshop.Image.11">
                  <p:embed/>
                </p:oleObj>
              </mc:Choice>
              <mc:Fallback>
                <p:oleObj name="Image" r:id="rId23" imgW="847080" imgH="20088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126810" y="5294151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276205"/>
              </p:ext>
            </p:extLst>
          </p:nvPr>
        </p:nvGraphicFramePr>
        <p:xfrm>
          <a:off x="3126810" y="5553752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8" name="Image" r:id="rId25" imgW="831960" imgH="237600" progId="Photoshop.Image.11">
                  <p:embed/>
                </p:oleObj>
              </mc:Choice>
              <mc:Fallback>
                <p:oleObj name="Image" r:id="rId25" imgW="831960" imgH="23760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126810" y="5553752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0026819"/>
              </p:ext>
            </p:extLst>
          </p:nvPr>
        </p:nvGraphicFramePr>
        <p:xfrm>
          <a:off x="3126810" y="6817748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89" name="Image" r:id="rId27" imgW="792360" imgH="164520" progId="Photoshop.Image.11">
                  <p:embed/>
                </p:oleObj>
              </mc:Choice>
              <mc:Fallback>
                <p:oleObj name="Image" r:id="rId27" imgW="792360" imgH="1645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126810" y="6817748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1799338" y="4087218"/>
            <a:ext cx="14283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0.1 µM </a:t>
            </a:r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Epirubicin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(24 h):</a:t>
            </a:r>
          </a:p>
        </p:txBody>
      </p:sp>
      <p:graphicFrame>
        <p:nvGraphicFramePr>
          <p:cNvPr id="50" name="Object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4761603"/>
              </p:ext>
            </p:extLst>
          </p:nvPr>
        </p:nvGraphicFramePr>
        <p:xfrm>
          <a:off x="3126810" y="5817565"/>
          <a:ext cx="810000" cy="20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90" name="Image" r:id="rId29" imgW="862560" imgH="246600" progId="Photoshop.Image.11">
                  <p:embed/>
                </p:oleObj>
              </mc:Choice>
              <mc:Fallback>
                <p:oleObj name="Image" r:id="rId29" imgW="862560" imgH="24660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3126810" y="5817565"/>
                        <a:ext cx="810000" cy="2016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1" name="Picture 50">
            <a:extLst>
              <a:ext uri="{FF2B5EF4-FFF2-40B4-BE49-F238E27FC236}">
                <a16:creationId xmlns:a16="http://schemas.microsoft.com/office/drawing/2014/main" id="{D7C49BA0-6E85-4C44-A13E-E4FE38A305B9}"/>
              </a:ext>
            </a:extLst>
          </p:cNvPr>
          <p:cNvPicPr preferRelativeResize="0"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3126810" y="6066703"/>
            <a:ext cx="810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004EB497-D418-5443-A095-A9F75C10CBA9}"/>
              </a:ext>
            </a:extLst>
          </p:cNvPr>
          <p:cNvSpPr txBox="1"/>
          <p:nvPr/>
        </p:nvSpPr>
        <p:spPr>
          <a:xfrm>
            <a:off x="2270158" y="5795812"/>
            <a:ext cx="85228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-AKT(S473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04EB497-D418-5443-A095-A9F75C10CBA9}"/>
              </a:ext>
            </a:extLst>
          </p:cNvPr>
          <p:cNvSpPr txBox="1"/>
          <p:nvPr/>
        </p:nvSpPr>
        <p:spPr>
          <a:xfrm>
            <a:off x="2623392" y="6087289"/>
            <a:ext cx="46222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-28634" y="150761"/>
            <a:ext cx="5137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-28634" y="3259128"/>
            <a:ext cx="5137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8ACE5DF-2E81-F243-B9EA-5536CC9904A7}"/>
              </a:ext>
            </a:extLst>
          </p:cNvPr>
          <p:cNvSpPr txBox="1"/>
          <p:nvPr/>
        </p:nvSpPr>
        <p:spPr>
          <a:xfrm>
            <a:off x="4051800" y="5190791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D1FC709-615C-0C40-ADAC-49C90E806B46}"/>
              </a:ext>
            </a:extLst>
          </p:cNvPr>
          <p:cNvSpPr txBox="1">
            <a:spLocks/>
          </p:cNvSpPr>
          <p:nvPr/>
        </p:nvSpPr>
        <p:spPr>
          <a:xfrm>
            <a:off x="4051800" y="4746736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6F130A4-AF6F-D74B-9983-377E9DD84D71}"/>
              </a:ext>
            </a:extLst>
          </p:cNvPr>
          <p:cNvSpPr txBox="1">
            <a:spLocks/>
          </p:cNvSpPr>
          <p:nvPr/>
        </p:nvSpPr>
        <p:spPr>
          <a:xfrm>
            <a:off x="4051800" y="4460037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260kDa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C9DE789-E596-5141-8CE0-F0E9CAC29B55}"/>
              </a:ext>
            </a:extLst>
          </p:cNvPr>
          <p:cNvCxnSpPr>
            <a:cxnSpLocks/>
          </p:cNvCxnSpPr>
          <p:nvPr/>
        </p:nvCxnSpPr>
        <p:spPr>
          <a:xfrm flipV="1">
            <a:off x="3927876" y="548299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6599ADB2-9D57-4A42-9D32-24A68E8793CE}"/>
              </a:ext>
            </a:extLst>
          </p:cNvPr>
          <p:cNvCxnSpPr>
            <a:cxnSpLocks/>
          </p:cNvCxnSpPr>
          <p:nvPr/>
        </p:nvCxnSpPr>
        <p:spPr>
          <a:xfrm flipV="1">
            <a:off x="3927876" y="453498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1C3ADAF0-6714-B549-B0DD-2ED3F55FA5A0}"/>
              </a:ext>
            </a:extLst>
          </p:cNvPr>
          <p:cNvCxnSpPr>
            <a:cxnSpLocks/>
          </p:cNvCxnSpPr>
          <p:nvPr/>
        </p:nvCxnSpPr>
        <p:spPr>
          <a:xfrm flipV="1">
            <a:off x="3927876" y="481424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7418C27-8EF0-E046-AEF6-40D7F265D4F9}"/>
              </a:ext>
            </a:extLst>
          </p:cNvPr>
          <p:cNvCxnSpPr>
            <a:cxnSpLocks/>
          </p:cNvCxnSpPr>
          <p:nvPr/>
        </p:nvCxnSpPr>
        <p:spPr>
          <a:xfrm flipV="1">
            <a:off x="3927876" y="529881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B463FDC3-A252-6648-861B-F9A377FEA84A}"/>
              </a:ext>
            </a:extLst>
          </p:cNvPr>
          <p:cNvSpPr txBox="1"/>
          <p:nvPr/>
        </p:nvSpPr>
        <p:spPr>
          <a:xfrm>
            <a:off x="4051800" y="556791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8ACE5DF-2E81-F243-B9EA-5536CC9904A7}"/>
              </a:ext>
            </a:extLst>
          </p:cNvPr>
          <p:cNvSpPr txBox="1"/>
          <p:nvPr/>
        </p:nvSpPr>
        <p:spPr>
          <a:xfrm>
            <a:off x="4051800" y="5411917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87418C27-8EF0-E046-AEF6-40D7F265D4F9}"/>
              </a:ext>
            </a:extLst>
          </p:cNvPr>
          <p:cNvCxnSpPr>
            <a:cxnSpLocks/>
          </p:cNvCxnSpPr>
          <p:nvPr/>
        </p:nvCxnSpPr>
        <p:spPr>
          <a:xfrm flipV="1">
            <a:off x="3927876" y="556489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594A700E-FBD6-8A4D-8D18-4F12DE982D46}"/>
              </a:ext>
            </a:extLst>
          </p:cNvPr>
          <p:cNvSpPr txBox="1">
            <a:spLocks/>
          </p:cNvSpPr>
          <p:nvPr/>
        </p:nvSpPr>
        <p:spPr>
          <a:xfrm>
            <a:off x="4051800" y="5752776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49D8FE4-C8C1-7543-8303-6F6E0893CA49}"/>
              </a:ext>
            </a:extLst>
          </p:cNvPr>
          <p:cNvSpPr txBox="1">
            <a:spLocks/>
          </p:cNvSpPr>
          <p:nvPr/>
        </p:nvSpPr>
        <p:spPr>
          <a:xfrm>
            <a:off x="4051800" y="6069925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32AD002D-11E2-3940-9DD5-32D2608F703B}"/>
              </a:ext>
            </a:extLst>
          </p:cNvPr>
          <p:cNvCxnSpPr>
            <a:cxnSpLocks/>
          </p:cNvCxnSpPr>
          <p:nvPr/>
        </p:nvCxnSpPr>
        <p:spPr>
          <a:xfrm flipV="1">
            <a:off x="3927876" y="590532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7B8D57E-BF22-A141-83AA-853893D34841}"/>
              </a:ext>
            </a:extLst>
          </p:cNvPr>
          <p:cNvCxnSpPr>
            <a:cxnSpLocks/>
          </p:cNvCxnSpPr>
          <p:nvPr/>
        </p:nvCxnSpPr>
        <p:spPr>
          <a:xfrm flipV="1">
            <a:off x="3927876" y="615045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D1FC709-615C-0C40-ADAC-49C90E806B46}"/>
              </a:ext>
            </a:extLst>
          </p:cNvPr>
          <p:cNvSpPr txBox="1">
            <a:spLocks/>
          </p:cNvSpPr>
          <p:nvPr/>
        </p:nvSpPr>
        <p:spPr>
          <a:xfrm>
            <a:off x="4051800" y="494594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C3ADAF0-6714-B549-B0DD-2ED3F55FA5A0}"/>
              </a:ext>
            </a:extLst>
          </p:cNvPr>
          <p:cNvCxnSpPr>
            <a:cxnSpLocks/>
          </p:cNvCxnSpPr>
          <p:nvPr/>
        </p:nvCxnSpPr>
        <p:spPr>
          <a:xfrm flipV="1">
            <a:off x="3927876" y="505417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98D09D50-93DC-9349-94ED-9F856348F294}"/>
              </a:ext>
            </a:extLst>
          </p:cNvPr>
          <p:cNvSpPr txBox="1">
            <a:spLocks/>
          </p:cNvSpPr>
          <p:nvPr/>
        </p:nvSpPr>
        <p:spPr>
          <a:xfrm>
            <a:off x="4021048" y="6842883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94A700E-FBD6-8A4D-8D18-4F12DE982D46}"/>
              </a:ext>
            </a:extLst>
          </p:cNvPr>
          <p:cNvSpPr txBox="1">
            <a:spLocks/>
          </p:cNvSpPr>
          <p:nvPr/>
        </p:nvSpPr>
        <p:spPr>
          <a:xfrm>
            <a:off x="4021048" y="6286888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49D8FE4-C8C1-7543-8303-6F6E0893CA49}"/>
              </a:ext>
            </a:extLst>
          </p:cNvPr>
          <p:cNvSpPr txBox="1">
            <a:spLocks/>
          </p:cNvSpPr>
          <p:nvPr/>
        </p:nvSpPr>
        <p:spPr>
          <a:xfrm>
            <a:off x="4021048" y="651540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32AD002D-11E2-3940-9DD5-32D2608F703B}"/>
              </a:ext>
            </a:extLst>
          </p:cNvPr>
          <p:cNvCxnSpPr>
            <a:cxnSpLocks/>
          </p:cNvCxnSpPr>
          <p:nvPr/>
        </p:nvCxnSpPr>
        <p:spPr>
          <a:xfrm flipV="1">
            <a:off x="3927876" y="633688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57B8D57E-BF22-A141-83AA-853893D34841}"/>
              </a:ext>
            </a:extLst>
          </p:cNvPr>
          <p:cNvCxnSpPr>
            <a:cxnSpLocks/>
          </p:cNvCxnSpPr>
          <p:nvPr/>
        </p:nvCxnSpPr>
        <p:spPr>
          <a:xfrm flipV="1">
            <a:off x="3927876" y="659593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C48F9DD4-C333-B94C-A545-C3833B174DFF}"/>
              </a:ext>
            </a:extLst>
          </p:cNvPr>
          <p:cNvCxnSpPr>
            <a:cxnSpLocks/>
          </p:cNvCxnSpPr>
          <p:nvPr/>
        </p:nvCxnSpPr>
        <p:spPr>
          <a:xfrm flipV="1">
            <a:off x="3927876" y="700706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2D75AF86-AE09-EE45-AD55-E1CBBA38F980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038E41-581A-EE47-A3F0-E01208660DE8}"/>
              </a:ext>
            </a:extLst>
          </p:cNvPr>
          <p:cNvSpPr txBox="1"/>
          <p:nvPr/>
        </p:nvSpPr>
        <p:spPr>
          <a:xfrm>
            <a:off x="0" y="7171765"/>
            <a:ext cx="685800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GCN2 deletion on protein expression and clonogenicity of MEFs in response to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WT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gcn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deficient  MEFs were treated with 0, 5, 10, 25, 50 and 100 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or 48 h, then incubated with fresh media for 10 days and stained with crystal violet i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ssays. Representative images of at least 3 independent experiments are displayed. Th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sults of the cells were normalised to that of the WT MEFs withou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(Top right panel) . Th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sults of the cells were also normalised to that of the respective WT and 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gcn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deficient  MEFs withou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(Bottom right panel)  Data are representative of 3 independent experiments.  Data represent means ± SEM. (n = 3; 2-way ANOVA). Significant **P &lt; 0.01, ***P &lt; 0.001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ression levels of protein in WT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gcn2</a:t>
            </a:r>
            <a:r>
              <a:rPr lang="en-GB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EFs in response to 0.1 µM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24 h). Western blot analysis was carried ou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to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determine the expression of P-Foxo3 (T32) (95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Foxo3 (85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Gcn2 (22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erk (14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-eIF2a (38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eIF2a (38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, P-AKT (S473) (6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, AKT (6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 and β-Tubulin (55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8748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2</TotalTime>
  <Words>328</Words>
  <Application>Microsoft Macintosh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1</cp:revision>
  <cp:lastPrinted>2019-09-13T13:01:11Z</cp:lastPrinted>
  <dcterms:created xsi:type="dcterms:W3CDTF">2017-05-18T08:37:50Z</dcterms:created>
  <dcterms:modified xsi:type="dcterms:W3CDTF">2020-04-28T13:41:47Z</dcterms:modified>
</cp:coreProperties>
</file>